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1334" y="2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10115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23755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77076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670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90586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06558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66530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85468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68364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54892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0506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C94D8-D31C-49B4-8A1F-5A56F22CBD2D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A7E38-D77C-4006-A50B-9CE8D0152BE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96897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24986086-99F8-4725-870C-A2F216BF9B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" y="81474"/>
            <a:ext cx="8961120" cy="5440680"/>
          </a:xfrm>
          <a:prstGeom prst="rect">
            <a:avLst/>
          </a:prstGeom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83CDAC8D-AE1A-4C25-8D32-517122B37A46}"/>
              </a:ext>
            </a:extLst>
          </p:cNvPr>
          <p:cNvSpPr/>
          <p:nvPr/>
        </p:nvSpPr>
        <p:spPr>
          <a:xfrm>
            <a:off x="91439" y="5701661"/>
            <a:ext cx="8961119" cy="10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imeline scheme of acute toxicity studies described in experimental procedure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oxicological effects of RHTR were determined in female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LB/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according to guideline 425 by OECD: “Up-and-Down” method. AE: aqueous extract; FF: flavonoid fraction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p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traperitoneal; LD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edian lethal dose. </a:t>
            </a:r>
            <a:endParaRPr lang="es-MX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82396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1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Varela Rodriguez</dc:creator>
  <cp:lastModifiedBy>Luis Varela Rodriguez</cp:lastModifiedBy>
  <cp:revision>1</cp:revision>
  <dcterms:created xsi:type="dcterms:W3CDTF">2019-03-29T00:23:39Z</dcterms:created>
  <dcterms:modified xsi:type="dcterms:W3CDTF">2019-03-29T00:24:47Z</dcterms:modified>
</cp:coreProperties>
</file>